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2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E249B-503D-4F53-B763-EEFFDEA64A51}" type="datetimeFigureOut">
              <a:rPr lang="en-US" smtClean="0"/>
              <a:pPr/>
              <a:t>7/19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30D5E-D426-488F-BCC3-DE6D931A19EE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/>
        </p:nvGraphicFramePr>
        <p:xfrm>
          <a:off x="381000" y="685800"/>
          <a:ext cx="8305801" cy="5692967"/>
        </p:xfrm>
        <a:graphic>
          <a:graphicData uri="http://schemas.openxmlformats.org/drawingml/2006/table">
            <a:tbl>
              <a:tblPr/>
              <a:tblGrid>
                <a:gridCol w="4114800"/>
                <a:gridCol w="1427519"/>
                <a:gridCol w="1612032"/>
                <a:gridCol w="1151450"/>
              </a:tblGrid>
              <a:tr h="34240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Detergent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 smtClean="0">
                          <a:latin typeface="Times New Roman"/>
                          <a:ea typeface="SimSun"/>
                          <a:cs typeface="Times New Roman"/>
                        </a:rPr>
                        <a:t>Concentration </a:t>
                      </a: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(% w/v)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CMC of detergent in water, mM (%), (literature data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% solubilized CB</a:t>
                      </a:r>
                      <a:r>
                        <a:rPr lang="de-DE" sz="1000" baseline="-25000" dirty="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 baseline="-25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hexyl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-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10 (8.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7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octyl-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ed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9.5 (0.8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5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non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 (0.28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7.6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dec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ed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.8 (0.08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58.4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undec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9 (0.02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0.6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dodec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pyranoside (DDM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7 (0.008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00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DDM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7 (0.008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8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hex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7 (0.008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hept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0 (1.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oct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 (OG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8 (0.53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45.8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nonyl-</a:t>
                      </a:r>
                      <a:r>
                        <a:rPr lang="de-DE" sz="1000">
                          <a:latin typeface="Agency FB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.5 (0.20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7.6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dec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.2 (0.0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dodec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glucopyranosid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0.19 (0.0066%)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51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3-[(3-cholamidopropyl)-dimethylammonio]-1-propane sulfonate  (CHAPS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 (0.4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41.7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CHAPS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 (0.4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9.7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CHAPS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 (0.4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3.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DDM (0.1%) + CHAPS (0.5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DE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ot availabl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53.4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DDM (1%) + CHAPS (0.5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de-DE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ot available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00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Cymal 5 (5-cyclohexyl-1-pentyl-</a:t>
                      </a:r>
                      <a:r>
                        <a:rPr lang="de-DE" sz="1000">
                          <a:latin typeface="Symbol"/>
                          <a:ea typeface="SimSun"/>
                          <a:cs typeface="Times New Roman"/>
                        </a:rPr>
                        <a:t>b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-maltoside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.4 (0.12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8.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60847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Polyoxyethylene(20)sorbitan </a:t>
                      </a:r>
                      <a:r>
                        <a:rPr lang="de-DE" sz="1000" dirty="0" smtClean="0">
                          <a:latin typeface="Times New Roman"/>
                          <a:ea typeface="SimSun"/>
                          <a:cs typeface="Times New Roman"/>
                        </a:rPr>
                        <a:t>monolaurate</a:t>
                      </a:r>
                      <a:r>
                        <a:rPr lang="en-US" sz="10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de-DE" sz="1000" dirty="0" smtClean="0">
                          <a:latin typeface="Times New Roman"/>
                          <a:ea typeface="SimSun"/>
                          <a:cs typeface="Times New Roman"/>
                        </a:rPr>
                        <a:t>(Tween </a:t>
                      </a: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20)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059 (0.0072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.7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Tween 20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059 (0.0072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5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Anapoe C</a:t>
                      </a:r>
                      <a:r>
                        <a:rPr lang="de-DE" sz="1000" baseline="-25000">
                          <a:latin typeface="Times New Roman"/>
                          <a:ea typeface="SimSun"/>
                          <a:cs typeface="Times New Roman"/>
                        </a:rPr>
                        <a:t>8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E</a:t>
                      </a:r>
                      <a:r>
                        <a:rPr lang="de-DE" sz="1000" baseline="-25000">
                          <a:latin typeface="Times New Roman"/>
                          <a:ea typeface="SimSun"/>
                          <a:cs typeface="Times New Roman"/>
                        </a:rPr>
                        <a:t>4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 (0.24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5.4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Anapoe C</a:t>
                      </a:r>
                      <a:r>
                        <a:rPr lang="de-DE" sz="1000" baseline="-25000">
                          <a:latin typeface="Times New Roman"/>
                          <a:ea typeface="SimSun"/>
                          <a:cs typeface="Times New Roman"/>
                        </a:rPr>
                        <a:t>10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E</a:t>
                      </a:r>
                      <a:r>
                        <a:rPr lang="de-DE" sz="1000" baseline="-25000">
                          <a:latin typeface="Times New Roman"/>
                          <a:ea typeface="SimSun"/>
                          <a:cs typeface="Times New Roman"/>
                        </a:rPr>
                        <a:t>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.3  (0.071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0.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Octanoyl-N-methylglucamide (MEGA 8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9 (2.5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4.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onanoyl-N-methylglucamide (MEGA 9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5 (0.84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1.7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decanoyl-N-methylglucamide (MEGA 10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 (0.21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81.3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i="1">
                          <a:latin typeface="Times New Roman"/>
                          <a:ea typeface="SimSun"/>
                          <a:cs typeface="Times New Roman"/>
                        </a:rPr>
                        <a:t>N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,</a:t>
                      </a:r>
                      <a:r>
                        <a:rPr lang="de-DE" sz="1000" i="1">
                          <a:latin typeface="Times New Roman"/>
                          <a:ea typeface="SimSun"/>
                          <a:cs typeface="Times New Roman"/>
                        </a:rPr>
                        <a:t>N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Dimethyldodecylamine-</a:t>
                      </a:r>
                      <a:r>
                        <a:rPr lang="de-DE" sz="1000" i="1">
                          <a:latin typeface="Times New Roman"/>
                          <a:ea typeface="SimSun"/>
                          <a:cs typeface="Times New Roman"/>
                        </a:rPr>
                        <a:t>N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-oxide</a:t>
                      </a:r>
                      <a:r>
                        <a:rPr lang="de-DE" sz="1000" b="1">
                          <a:latin typeface="Times New Roman"/>
                          <a:ea typeface="SimSun"/>
                          <a:cs typeface="Times New Roman"/>
                        </a:rPr>
                        <a:t> (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LDAO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 (0.046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0.8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LDAO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5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 (0.046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6.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LDAO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 (0.046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4.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871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n-octyl-N,N-dimethyl-3-ammonio-1-propanesulfonate (Anzergent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 3-8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390 (10.9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76.6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395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n-decyl-N,N-dimethyl-3-ammonio-1-propanesulfonate</a:t>
                      </a:r>
                      <a:r>
                        <a:rPr lang="de-DE" sz="1000" b="1">
                          <a:solidFill>
                            <a:srgbClr val="4D4F53"/>
                          </a:solidFill>
                          <a:latin typeface="Verdana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(Anzergent 3-10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39 (1.2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5.3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37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n-dodecyl-N,N-dimethyl-3-ammonio-1-propanesulfonate (Anzergent</a:t>
                      </a: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 3-12)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.8 (0.094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4.9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970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n-tetradecyl-N,N-dimethyl-3-ammonio-1-propanesulfonate</a:t>
                      </a:r>
                      <a:r>
                        <a:rPr lang="de-DE" sz="1000" b="1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 (</a:t>
                      </a:r>
                      <a:r>
                        <a:rPr lang="de-DE" sz="1000">
                          <a:solidFill>
                            <a:srgbClr val="000000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nzergent 3-14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0.2 (0.007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93.6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n-octylphosphocholine (Fos-choline-8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114 (3.4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66.7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2174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n-nonylphosphocholine (Fos-choline-9)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2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latin typeface="Times New Roman"/>
                          <a:ea typeface="SimSun"/>
                          <a:cs typeface="Times New Roman"/>
                        </a:rPr>
                        <a:t>39.5 (1.2%)</a:t>
                      </a:r>
                      <a:endParaRPr lang="en-US" sz="100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dirty="0">
                          <a:latin typeface="Times New Roman"/>
                          <a:ea typeface="SimSun"/>
                          <a:cs typeface="Times New Roman"/>
                        </a:rPr>
                        <a:t>70.3</a:t>
                      </a:r>
                      <a:endParaRPr lang="en-US" sz="10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41564" marR="41564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025" name="Rectangle 1"/>
          <p:cNvSpPr>
            <a:spLocks noChangeArrowheads="1"/>
          </p:cNvSpPr>
          <p:nvPr/>
        </p:nvSpPr>
        <p:spPr bwMode="auto">
          <a:xfrm>
            <a:off x="1219200" y="228600"/>
            <a:ext cx="65532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Table S1. Efficiency of detergents in solubilization of recombinant CB</a:t>
            </a:r>
            <a:r>
              <a:rPr kumimoji="0" lang="de-DE" sz="1200" b="0" i="0" u="none" strike="noStrike" cap="none" normalizeH="0" baseline="-3000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2</a:t>
            </a:r>
            <a:r>
              <a: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from </a:t>
            </a:r>
            <a:r>
              <a:rPr kumimoji="0" lang="de-DE" sz="12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E. coli</a:t>
            </a:r>
            <a:r>
              <a:rPr kumimoji="0" lang="de-DE" sz="12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Times New Roman" pitchFamily="18" charset="0"/>
                <a:ea typeface="SimSun" pitchFamily="2" charset="-122"/>
                <a:cs typeface="Times New Roman" pitchFamily="18" charset="0"/>
              </a:rPr>
              <a:t> membranes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358</Words>
  <Application>Microsoft Office PowerPoint</Application>
  <PresentationFormat>On-screen Show (4:3)</PresentationFormat>
  <Paragraphs>14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NIAA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eliseeva</dc:creator>
  <cp:lastModifiedBy>yeliseeva</cp:lastModifiedBy>
  <cp:revision>17</cp:revision>
  <dcterms:created xsi:type="dcterms:W3CDTF">2011-07-08T16:16:57Z</dcterms:created>
  <dcterms:modified xsi:type="dcterms:W3CDTF">2012-07-19T19:13:36Z</dcterms:modified>
</cp:coreProperties>
</file>